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54" r:id="rId2"/>
    <p:sldId id="364" r:id="rId3"/>
    <p:sldId id="363" r:id="rId4"/>
    <p:sldId id="370" r:id="rId5"/>
    <p:sldId id="361" r:id="rId6"/>
    <p:sldId id="369" r:id="rId7"/>
    <p:sldId id="362" r:id="rId8"/>
    <p:sldId id="371" r:id="rId9"/>
    <p:sldId id="358" r:id="rId10"/>
    <p:sldId id="372" r:id="rId11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912"/>
    <p:restoredTop sz="96224"/>
  </p:normalViewPr>
  <p:slideViewPr>
    <p:cSldViewPr snapToGrid="0" snapToObjects="1">
      <p:cViewPr>
        <p:scale>
          <a:sx n="200" d="100"/>
          <a:sy n="200" d="100"/>
        </p:scale>
        <p:origin x="144" y="-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34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67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70479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 Column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370332" y="2648618"/>
            <a:ext cx="4346924" cy="5924350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lnSpc>
                <a:spcPts val="1463"/>
              </a:lnSpc>
              <a:buNone/>
              <a:defRPr sz="1013" b="0" i="0" spc="-28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lvl1pPr>
            <a:lvl2pPr marL="257169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37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0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674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4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1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18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349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 err="1"/>
              <a:t>Em</a:t>
            </a:r>
            <a:r>
              <a:rPr lang="en-US" dirty="0"/>
              <a:t> </a:t>
            </a:r>
            <a:r>
              <a:rPr lang="en-US" dirty="0" err="1"/>
              <a:t>psum</a:t>
            </a:r>
            <a:r>
              <a:rPr lang="en-US" dirty="0"/>
              <a:t> dolor sit </a:t>
            </a:r>
            <a:r>
              <a:rPr lang="en-US" dirty="0" err="1"/>
              <a:t>amet</a:t>
            </a:r>
            <a:r>
              <a:rPr lang="en-US" dirty="0"/>
              <a:t>, </a:t>
            </a:r>
            <a:r>
              <a:rPr lang="en-US" dirty="0" err="1"/>
              <a:t>consectetur</a:t>
            </a:r>
            <a:r>
              <a:rPr lang="en-US" dirty="0"/>
              <a:t> </a:t>
            </a:r>
            <a:r>
              <a:rPr lang="en-US" dirty="0" err="1"/>
              <a:t>adipiscing</a:t>
            </a:r>
            <a:r>
              <a:rPr lang="en-US" dirty="0"/>
              <a:t> </a:t>
            </a:r>
            <a:r>
              <a:rPr lang="en-US" dirty="0" err="1"/>
              <a:t>elit</a:t>
            </a:r>
            <a:r>
              <a:rPr lang="en-US" dirty="0"/>
              <a:t>. </a:t>
            </a:r>
            <a:r>
              <a:rPr lang="en-US" dirty="0" err="1"/>
              <a:t>Mauris</a:t>
            </a:r>
            <a:r>
              <a:rPr lang="en-US" dirty="0"/>
              <a:t> </a:t>
            </a:r>
            <a:r>
              <a:rPr lang="en-US" dirty="0" err="1"/>
              <a:t>vehicula</a:t>
            </a:r>
            <a:r>
              <a:rPr lang="en-US" dirty="0"/>
              <a:t> dui in </a:t>
            </a:r>
            <a:r>
              <a:rPr lang="en-US" dirty="0" err="1"/>
              <a:t>neque</a:t>
            </a:r>
            <a:r>
              <a:rPr lang="en-US" dirty="0"/>
              <a:t> </a:t>
            </a:r>
            <a:r>
              <a:rPr lang="en-US" dirty="0" err="1"/>
              <a:t>dignissim</a:t>
            </a:r>
            <a:r>
              <a:rPr lang="en-US" dirty="0"/>
              <a:t>, in </a:t>
            </a:r>
            <a:r>
              <a:rPr lang="en-US" dirty="0" err="1"/>
              <a:t>aliquet</a:t>
            </a:r>
            <a:r>
              <a:rPr lang="en-US" dirty="0"/>
              <a:t> </a:t>
            </a:r>
            <a:r>
              <a:rPr lang="en-US" dirty="0" err="1"/>
              <a:t>nisl</a:t>
            </a:r>
            <a:r>
              <a:rPr lang="en-US" dirty="0"/>
              <a:t> </a:t>
            </a:r>
            <a:r>
              <a:rPr lang="en-US" dirty="0" err="1"/>
              <a:t>varius</a:t>
            </a:r>
            <a:r>
              <a:rPr lang="en-US" dirty="0"/>
              <a:t>. </a:t>
            </a:r>
            <a:r>
              <a:rPr lang="en-US" dirty="0" err="1"/>
              <a:t>Sed</a:t>
            </a:r>
            <a:r>
              <a:rPr lang="en-US" dirty="0"/>
              <a:t> a </a:t>
            </a:r>
            <a:r>
              <a:rPr lang="en-US" dirty="0" err="1"/>
              <a:t>erat</a:t>
            </a:r>
            <a:r>
              <a:rPr lang="en-US" dirty="0"/>
              <a:t> </a:t>
            </a:r>
            <a:r>
              <a:rPr lang="en-US" dirty="0" err="1"/>
              <a:t>ut</a:t>
            </a:r>
            <a:r>
              <a:rPr lang="en-US" dirty="0"/>
              <a:t> magna </a:t>
            </a:r>
            <a:r>
              <a:rPr lang="en-US" dirty="0" err="1"/>
              <a:t>vulputate</a:t>
            </a:r>
            <a:r>
              <a:rPr lang="en-US" dirty="0"/>
              <a:t> </a:t>
            </a:r>
            <a:r>
              <a:rPr lang="en-US" dirty="0" err="1"/>
              <a:t>feugiat</a:t>
            </a:r>
            <a:r>
              <a:rPr lang="en-US" dirty="0"/>
              <a:t>. </a:t>
            </a:r>
            <a:r>
              <a:rPr lang="en-US" dirty="0" err="1"/>
              <a:t>Quisque</a:t>
            </a:r>
            <a:r>
              <a:rPr lang="en-US" dirty="0"/>
              <a:t> </a:t>
            </a:r>
            <a:r>
              <a:rPr lang="en-US" dirty="0" err="1"/>
              <a:t>varius</a:t>
            </a:r>
            <a:r>
              <a:rPr lang="en-US" dirty="0"/>
              <a:t> libero </a:t>
            </a:r>
            <a:r>
              <a:rPr lang="en-US" dirty="0" err="1"/>
              <a:t>placerat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 </a:t>
            </a:r>
            <a:r>
              <a:rPr lang="en-US" dirty="0" err="1"/>
              <a:t>lobortis</a:t>
            </a:r>
            <a:r>
              <a:rPr lang="en-US" dirty="0"/>
              <a:t> </a:t>
            </a:r>
            <a:r>
              <a:rPr lang="en-US" dirty="0" err="1"/>
              <a:t>congue</a:t>
            </a:r>
            <a:r>
              <a:rPr lang="en-US" dirty="0"/>
              <a:t>. Integer a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vel</a:t>
            </a:r>
            <a:r>
              <a:rPr lang="en-US" dirty="0"/>
              <a:t> ante </a:t>
            </a:r>
            <a:r>
              <a:rPr lang="en-US" dirty="0" err="1"/>
              <a:t>bibendum</a:t>
            </a:r>
            <a:r>
              <a:rPr lang="en-US" dirty="0"/>
              <a:t> </a:t>
            </a:r>
            <a:r>
              <a:rPr lang="en-US" dirty="0" err="1"/>
              <a:t>scelerisque</a:t>
            </a:r>
            <a:r>
              <a:rPr lang="en-US" dirty="0"/>
              <a:t>. Class </a:t>
            </a:r>
            <a:r>
              <a:rPr lang="en-US" dirty="0" err="1"/>
              <a:t>aptent</a:t>
            </a:r>
            <a:r>
              <a:rPr lang="en-US" dirty="0"/>
              <a:t> </a:t>
            </a:r>
            <a:r>
              <a:rPr lang="en-US" dirty="0" err="1"/>
              <a:t>taciti</a:t>
            </a:r>
            <a:r>
              <a:rPr lang="en-US" dirty="0"/>
              <a:t> </a:t>
            </a:r>
            <a:r>
              <a:rPr lang="en-US" dirty="0" err="1"/>
              <a:t>sociosqu</a:t>
            </a:r>
            <a:r>
              <a:rPr lang="en-US" dirty="0"/>
              <a:t> ad </a:t>
            </a:r>
            <a:r>
              <a:rPr lang="en-US" dirty="0" err="1"/>
              <a:t>litora</a:t>
            </a:r>
            <a:r>
              <a:rPr lang="en-US" dirty="0"/>
              <a:t> </a:t>
            </a:r>
            <a:r>
              <a:rPr lang="en-US" dirty="0" err="1"/>
              <a:t>torquent</a:t>
            </a:r>
            <a:r>
              <a:rPr lang="en-US" dirty="0"/>
              <a:t>.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 hasCustomPrompt="1"/>
          </p:nvPr>
        </p:nvSpPr>
        <p:spPr>
          <a:xfrm>
            <a:off x="370332" y="1421977"/>
            <a:ext cx="5915025" cy="1034344"/>
          </a:xfrm>
          <a:prstGeom prst="rect">
            <a:avLst/>
          </a:prstGeom>
        </p:spPr>
        <p:txBody>
          <a:bodyPr anchor="b">
            <a:normAutofit/>
          </a:bodyPr>
          <a:lstStyle>
            <a:lvl1pPr>
              <a:lnSpc>
                <a:spcPct val="80000"/>
              </a:lnSpc>
              <a:defRPr sz="2025" b="0" i="0">
                <a:solidFill>
                  <a:srgbClr val="1D4F9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1584981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963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41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682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284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915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716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89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182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8CDDC-E56B-7340-A160-ACDF07D92593}" type="datetimeFigureOut">
              <a:rPr lang="en-US" smtClean="0"/>
              <a:t>12/1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77396-F118-C241-84C7-AEE02CD79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77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1FBF9B8E-3835-14FE-3C09-2C6DF5BF7559}"/>
              </a:ext>
            </a:extLst>
          </p:cNvPr>
          <p:cNvGrpSpPr/>
          <p:nvPr/>
        </p:nvGrpSpPr>
        <p:grpSpPr>
          <a:xfrm>
            <a:off x="1483442" y="286439"/>
            <a:ext cx="742623" cy="5986294"/>
            <a:chOff x="-7886950" y="-9503716"/>
            <a:chExt cx="1583658" cy="8870836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9CAF84D-5DBF-7F45-1360-552354902C71}"/>
                </a:ext>
              </a:extLst>
            </p:cNvPr>
            <p:cNvSpPr txBox="1"/>
            <p:nvPr/>
          </p:nvSpPr>
          <p:spPr>
            <a:xfrm>
              <a:off x="-7886950" y="-9503716"/>
              <a:ext cx="158365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76747CC-3C34-0CFA-FB8C-2BF677EB5B21}"/>
                </a:ext>
              </a:extLst>
            </p:cNvPr>
            <p:cNvSpPr txBox="1"/>
            <p:nvPr/>
          </p:nvSpPr>
          <p:spPr>
            <a:xfrm>
              <a:off x="-7886950" y="-1420487"/>
              <a:ext cx="1188208" cy="7876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688D86E9-C004-7071-3628-14817942F3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6050" y="6350"/>
            <a:ext cx="4025900" cy="989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64453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E3F58E-4F9E-B8D0-5F70-223EF418B3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6E13EA9-62A3-F477-E176-3E727505AF3C}"/>
              </a:ext>
            </a:extLst>
          </p:cNvPr>
          <p:cNvSpPr txBox="1"/>
          <p:nvPr/>
        </p:nvSpPr>
        <p:spPr>
          <a:xfrm>
            <a:off x="355294" y="484743"/>
            <a:ext cx="6147412" cy="2654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buNone/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5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seline Gene Expression of TREM2 and TYROBP by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3 rs3865444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PI1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s1057233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s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NA expression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EM 2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,c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YROBP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,d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 untreated human monocytes.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EM2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NA expression stratified by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3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s3865444</a:t>
            </a:r>
            <a:r>
              <a:rPr lang="en-US" sz="11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.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YROBP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NA expression stratified by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3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s3865444</a:t>
            </a:r>
            <a:r>
              <a:rPr lang="en-US" sz="11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.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c)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EM2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NA expression stratified by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PI1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s1057233</a:t>
            </a:r>
            <a:r>
              <a:rPr lang="en-US" sz="11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d)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YROBP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NA expression stratified by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PI1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s1057233</a:t>
            </a:r>
            <a:r>
              <a:rPr lang="en-US" sz="11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. Gene expression results were measured using quantitative real-time PCR and were normalized to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PDH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expression. Results are depicted as the delta CT value between the gene of interest and GAPDH times 1000. Data is presented as the mean </a:t>
            </a:r>
            <a:r>
              <a:rPr lang="en-US" sz="1100" u="sng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M, and each dot represents an individual donor.</a:t>
            </a:r>
          </a:p>
          <a:p>
            <a:pPr marL="0" marR="0">
              <a:lnSpc>
                <a:spcPct val="150000"/>
              </a:lnSpc>
              <a:buNone/>
            </a:pP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ne-way ANOVA with Sidak’s multiple comparison test *p&lt;0.05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5776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C56BC27-68CC-3B17-012D-DFA6B8CE2D4F}"/>
              </a:ext>
            </a:extLst>
          </p:cNvPr>
          <p:cNvSpPr txBox="1"/>
          <p:nvPr/>
        </p:nvSpPr>
        <p:spPr>
          <a:xfrm>
            <a:off x="355294" y="484743"/>
            <a:ext cx="6147412" cy="18928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buNone/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hagocytosis and Surface Staining Controls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nocyt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hagocytosis of fluorescently labeled amyloid beta peptide 1-42 following incubation with cytochalasin D for 30 minutes.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nocyt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rface expression of TREM2 or isotype control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data were collected with flow cytometry and represented as geometric mean fluorescence intensity. Each dot represents an individual donor. For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ata is presented as mean </a:t>
            </a:r>
            <a:r>
              <a:rPr lang="en-US" sz="1100" u="sng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M,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aired samples are connected by a line. Paired Student’s t-test, ***p&lt;0.001, ****p&lt;0.0001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7569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A3901AB8-ABC8-C708-B495-655CA5011DD1}"/>
              </a:ext>
            </a:extLst>
          </p:cNvPr>
          <p:cNvGrpSpPr/>
          <p:nvPr/>
        </p:nvGrpSpPr>
        <p:grpSpPr>
          <a:xfrm>
            <a:off x="1526283" y="697653"/>
            <a:ext cx="742623" cy="5350607"/>
            <a:chOff x="-7886950" y="-9503716"/>
            <a:chExt cx="1583658" cy="7744382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E0A6537-95B5-B39C-0379-218EB0C2EA9A}"/>
                </a:ext>
              </a:extLst>
            </p:cNvPr>
            <p:cNvSpPr txBox="1"/>
            <p:nvPr/>
          </p:nvSpPr>
          <p:spPr>
            <a:xfrm>
              <a:off x="-7886950" y="-9503716"/>
              <a:ext cx="158365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CBC2720-A6CD-2ACB-3EF0-B1910667CA48}"/>
                </a:ext>
              </a:extLst>
            </p:cNvPr>
            <p:cNvSpPr txBox="1"/>
            <p:nvPr/>
          </p:nvSpPr>
          <p:spPr>
            <a:xfrm>
              <a:off x="-7689223" y="-2546942"/>
              <a:ext cx="118820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4AEB5E86-8990-C122-E0A7-09404CDB0C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8829" y="298450"/>
            <a:ext cx="4533900" cy="9309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55472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92A834-2452-BCD8-93DE-73CCF15C14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06300EF-DB00-1913-D7EA-080DF0FFC392}"/>
              </a:ext>
            </a:extLst>
          </p:cNvPr>
          <p:cNvSpPr txBox="1"/>
          <p:nvPr/>
        </p:nvSpPr>
        <p:spPr>
          <a:xfrm>
            <a:off x="355294" y="484743"/>
            <a:ext cx="6147412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150000"/>
              </a:lnSpc>
              <a:buNone/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2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β Phagocytosis and TREM2 Surface Expression by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3 rs3865444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enotype. 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Monocyte phagocytosis of fluorescently labeled amyloid beta peptide 1-42 (Aβ1-42) following exposure to aggregated Aβ1-42 (Agg. Aβ) for 24 hours in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3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s3865444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 groups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.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nocyt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rface expression of TREM2 following exposure to aggregated Aβ1-42 (Agg. Aβ) for 24 hours in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D33</a:t>
            </a:r>
            <a:r>
              <a:rPr lang="en-US" sz="11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s3865444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enotype groups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data wer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sured with flow cytometry, represented as geometric mean fluorescence intensity and normalized for batch correction using the GraphPad Prism normalize function. Data is presented as the mean </a:t>
            </a:r>
            <a:r>
              <a:rPr lang="en-US" sz="1100" u="sng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M and each dot represents an individual donor. Two-way ANOVA with Sidak’s multiple comparison test *p&lt;0.05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64808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55423902-DD4E-09A1-7076-4D0CC8A0CB61}"/>
              </a:ext>
            </a:extLst>
          </p:cNvPr>
          <p:cNvGrpSpPr/>
          <p:nvPr/>
        </p:nvGrpSpPr>
        <p:grpSpPr>
          <a:xfrm>
            <a:off x="1526283" y="697653"/>
            <a:ext cx="742623" cy="5350607"/>
            <a:chOff x="-7886950" y="-9503716"/>
            <a:chExt cx="1583658" cy="774438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6275ECC-518A-2CD3-F3E6-4ED162FD5F6B}"/>
                </a:ext>
              </a:extLst>
            </p:cNvPr>
            <p:cNvSpPr txBox="1"/>
            <p:nvPr/>
          </p:nvSpPr>
          <p:spPr>
            <a:xfrm>
              <a:off x="-7886950" y="-9503716"/>
              <a:ext cx="158365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8EAE292-E725-6DB4-007D-AC1C7CEFEFB2}"/>
                </a:ext>
              </a:extLst>
            </p:cNvPr>
            <p:cNvSpPr txBox="1"/>
            <p:nvPr/>
          </p:nvSpPr>
          <p:spPr>
            <a:xfrm>
              <a:off x="-7689223" y="-2546942"/>
              <a:ext cx="118820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0659D443-C882-2BEF-6357-C7700A2ECC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8848" y="501650"/>
            <a:ext cx="3848100" cy="8902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00899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D8208A-FD81-2ED0-42B9-87311512FA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85FD4D-8424-8939-358F-60C63DF9AAFD}"/>
              </a:ext>
            </a:extLst>
          </p:cNvPr>
          <p:cNvSpPr txBox="1"/>
          <p:nvPr/>
        </p:nvSpPr>
        <p:spPr>
          <a:xfrm>
            <a:off x="355294" y="484743"/>
            <a:ext cx="6147412" cy="2146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150000"/>
              </a:lnSpc>
              <a:buNone/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3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β Phagocytosis and TREM2 Surface Expression Stratified by Sex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Monocyte phagocytosis of fluorescently labeled amyloid beta peptide 1-42 (Aβ1-42) following exposure to aggregated Aβ1-42 (Agg. Aβ) for 24 hours in males and females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.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nocyt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rface expression of TREM2 following exposure to aggregated Aβ1-42 (Agg. Aβ) for 24 hours in males and females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data wer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sured with flow cytometry, represented as geometric mean fluorescence intensity and normalized for batch correction using the GraphPad Prism normalize function. Data is presented as the mean </a:t>
            </a:r>
            <a:r>
              <a:rPr lang="en-US" sz="1100" u="sng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M and each dot represents an individual donor. Two-way ANOVA with Sidak’s multiple comparison test *p&lt;0.05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4965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8648219-BFFA-70BF-6C7E-1F3DF7156461}"/>
              </a:ext>
            </a:extLst>
          </p:cNvPr>
          <p:cNvGrpSpPr/>
          <p:nvPr/>
        </p:nvGrpSpPr>
        <p:grpSpPr>
          <a:xfrm>
            <a:off x="986456" y="1264569"/>
            <a:ext cx="742623" cy="4530302"/>
            <a:chOff x="-7886950" y="-9503716"/>
            <a:chExt cx="1583658" cy="774438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4321691-6146-249E-8041-5F03340C20B8}"/>
                </a:ext>
              </a:extLst>
            </p:cNvPr>
            <p:cNvSpPr txBox="1"/>
            <p:nvPr/>
          </p:nvSpPr>
          <p:spPr>
            <a:xfrm>
              <a:off x="-7886950" y="-9503716"/>
              <a:ext cx="158365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2A68FB0-B888-AA0D-9659-D35E967B7FD3}"/>
                </a:ext>
              </a:extLst>
            </p:cNvPr>
            <p:cNvSpPr txBox="1"/>
            <p:nvPr/>
          </p:nvSpPr>
          <p:spPr>
            <a:xfrm>
              <a:off x="-7689223" y="-2546942"/>
              <a:ext cx="118820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E71560C8-C4AD-9040-CF08-51831503D1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17" y="1253289"/>
            <a:ext cx="6858000" cy="73994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40732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0DC5568-9CBA-1E33-7314-CD0799DDE7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BBCA434-3F8D-9333-F2B0-AAE660CD94A1}"/>
              </a:ext>
            </a:extLst>
          </p:cNvPr>
          <p:cNvSpPr txBox="1"/>
          <p:nvPr/>
        </p:nvSpPr>
        <p:spPr>
          <a:xfrm>
            <a:off x="355294" y="484743"/>
            <a:ext cx="6147412" cy="18928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buNone/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4.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β Phagocytosis and TREM2 Surface Expression by Age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Monocyte phagocytosis of fluorescently labeled amyloid beta peptide 1-42 (Aβ1-42) following exposure to aggregated Aβ1-42 (Agg. Aβ) for 24 hours versus age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b.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onocyt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rface expression of TREM2 following exposure to aggregated Aβ1-42 (Agg. Aβ) for 24 hours versus age.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ll data wer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sured with flow cytometry, represented as geometric mean fluorescence intensity and normalized for batch correction using the GraphPad Prism normalize function. Simple linear regression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23924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B2BF851-F92E-C106-CBAA-F1CE232443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419100"/>
            <a:ext cx="6553200" cy="906780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D51DB969-4856-F56F-057C-DFB4B9E96F76}"/>
              </a:ext>
            </a:extLst>
          </p:cNvPr>
          <p:cNvGrpSpPr/>
          <p:nvPr/>
        </p:nvGrpSpPr>
        <p:grpSpPr>
          <a:xfrm>
            <a:off x="300821" y="576467"/>
            <a:ext cx="3888864" cy="369332"/>
            <a:chOff x="-7886950" y="-9503716"/>
            <a:chExt cx="8293078" cy="787608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B5AE1DE-D0B3-4A54-A970-B79A523C4666}"/>
                </a:ext>
              </a:extLst>
            </p:cNvPr>
            <p:cNvSpPr txBox="1"/>
            <p:nvPr/>
          </p:nvSpPr>
          <p:spPr>
            <a:xfrm>
              <a:off x="-7886950" y="-9503716"/>
              <a:ext cx="158365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17DB310-216F-7480-CB12-F54A6B6FB540}"/>
                </a:ext>
              </a:extLst>
            </p:cNvPr>
            <p:cNvSpPr txBox="1"/>
            <p:nvPr/>
          </p:nvSpPr>
          <p:spPr>
            <a:xfrm>
              <a:off x="-782080" y="-9503716"/>
              <a:ext cx="1188208" cy="7876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138286F6-3763-85A4-9A79-D4163B8A1E9B}"/>
              </a:ext>
            </a:extLst>
          </p:cNvPr>
          <p:cNvSpPr txBox="1"/>
          <p:nvPr/>
        </p:nvSpPr>
        <p:spPr>
          <a:xfrm>
            <a:off x="353151" y="5258807"/>
            <a:ext cx="745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51C211-C0D7-6AC0-7FFC-AC2D5C7C0498}"/>
              </a:ext>
            </a:extLst>
          </p:cNvPr>
          <p:cNvSpPr txBox="1"/>
          <p:nvPr/>
        </p:nvSpPr>
        <p:spPr>
          <a:xfrm>
            <a:off x="3635090" y="5258807"/>
            <a:ext cx="745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278849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848</TotalTime>
  <Words>600</Words>
  <Application>Microsoft Macintosh PowerPoint</Application>
  <PresentationFormat>A4 Paper (210x297 mm)</PresentationFormat>
  <Paragraphs>18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tila, Zena K.</dc:creator>
  <cp:lastModifiedBy>Elizabeth Bradshaw</cp:lastModifiedBy>
  <cp:revision>15</cp:revision>
  <dcterms:created xsi:type="dcterms:W3CDTF">2023-11-18T21:39:14Z</dcterms:created>
  <dcterms:modified xsi:type="dcterms:W3CDTF">2025-12-14T03:49:30Z</dcterms:modified>
</cp:coreProperties>
</file>